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BAF6CD-5775-4021-8CC8-59B618CE8A0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90130-C54E-4F51-8647-DDCFEBF8AB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58AE6-DEB7-4779-AB3C-CACAD6E985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3FDE4-A263-454D-A5B7-A1DB6D1DA9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C54FDC-EA2D-4B91-90CF-56C878FC5A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D80AF-5DF5-45B3-977E-298FB4C507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7E1F74-1DFD-4014-8898-3DAF8336B0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42A08-4D7A-4136-B9ED-2AAC88A38E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D35C1D-6B8B-4EA3-8CE8-8C4CCF81DF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B9704-7A0D-46F4-A827-40C5392796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4119A-0916-4D77-AC21-23A137299A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DA1F5-E9D3-4EFF-A5C1-6CB280BB77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A5579FE-AF95-42C5-80CF-FE3E75FBF00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wmf"/><Relationship Id="rId5" Type="http://schemas.openxmlformats.org/officeDocument/2006/relationships/oleObject" Target="../embeddings/oleObject2.bin"/><Relationship Id="rId6" Type="http://schemas.openxmlformats.org/officeDocument/2006/relationships/image" Target="../media/image4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014560" y="907920"/>
            <a:ext cx="5130360" cy="1738080"/>
            <a:chOff x="2014560" y="907920"/>
            <a:chExt cx="5130360" cy="1738080"/>
          </a:xfrm>
        </p:grpSpPr>
        <p:sp>
          <p:nvSpPr>
            <p:cNvPr id="42" name=""/>
            <p:cNvSpPr/>
            <p:nvPr/>
          </p:nvSpPr>
          <p:spPr>
            <a:xfrm>
              <a:off x="2381400" y="958680"/>
              <a:ext cx="1113480" cy="1647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70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µg/ml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205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6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238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271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304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85840"/>
                  <a:tab algn="ctr" pos="80028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           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verag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" descr=""/>
            <p:cNvPicPr/>
            <p:nvPr/>
          </p:nvPicPr>
          <p:blipFill>
            <a:blip r:embed="rId1"/>
            <a:srcRect l="5326" t="6383" r="9315" b="14775"/>
            <a:stretch/>
          </p:blipFill>
          <p:spPr>
            <a:xfrm>
              <a:off x="3396960" y="928440"/>
              <a:ext cx="3747960" cy="171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2014560" y="90792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"/>
          <p:cNvGrpSpPr/>
          <p:nvPr/>
        </p:nvGrpSpPr>
        <p:grpSpPr>
          <a:xfrm>
            <a:off x="549000" y="3021120"/>
            <a:ext cx="7978680" cy="2255040"/>
            <a:chOff x="549000" y="3021120"/>
            <a:chExt cx="7978680" cy="2255040"/>
          </a:xfrm>
        </p:grpSpPr>
        <p:pic>
          <p:nvPicPr>
            <p:cNvPr id="46" name="" descr=""/>
            <p:cNvPicPr/>
            <p:nvPr/>
          </p:nvPicPr>
          <p:blipFill>
            <a:blip r:embed="rId2"/>
            <a:srcRect l="5316" t="5018" r="10299" b="13381"/>
            <a:stretch/>
          </p:blipFill>
          <p:spPr>
            <a:xfrm>
              <a:off x="3835080" y="3021120"/>
              <a:ext cx="3711600" cy="178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549000" y="303372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48" name=""/>
            <p:cNvGraphicFramePr/>
            <p:nvPr/>
          </p:nvGraphicFramePr>
          <p:xfrm>
            <a:off x="1125360" y="3124080"/>
            <a:ext cx="1252440" cy="7257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125360" y="3124080"/>
                      <a:ext cx="1252440" cy="725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0" name=""/>
            <p:cNvGraphicFramePr/>
            <p:nvPr/>
          </p:nvGraphicFramePr>
          <p:xfrm>
            <a:off x="606240" y="4019760"/>
            <a:ext cx="1828800" cy="8222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606240" y="4019760"/>
                      <a:ext cx="1828800" cy="822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2" name=""/>
            <p:cNvSpPr/>
            <p:nvPr/>
          </p:nvSpPr>
          <p:spPr>
            <a:xfrm>
              <a:off x="2234880" y="3111480"/>
              <a:ext cx="1719360" cy="216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70000"/>
                </a:lnSpc>
                <a:tabLst>
                  <a:tab algn="l" pos="0"/>
                  <a:tab algn="ctr" pos="1036800"/>
                  <a:tab algn="ctr" pos="13716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µg/ml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1036800"/>
                  <a:tab algn="ctr" pos="13716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C69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5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1036800"/>
                  <a:tab algn="ctr" pos="13716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C69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50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1036800"/>
                  <a:tab algn="ctr" pos="13716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C1384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4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1036800"/>
                  <a:tab algn="ctr" pos="13716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CC1384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0.32                            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1036800"/>
                  <a:tab algn="ctr" pos="13716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verag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3" name=""/>
            <p:cNvGrpSpPr/>
            <p:nvPr/>
          </p:nvGrpSpPr>
          <p:grpSpPr>
            <a:xfrm>
              <a:off x="7503840" y="3440160"/>
              <a:ext cx="1023840" cy="1096560"/>
              <a:chOff x="7503840" y="3440160"/>
              <a:chExt cx="1023840" cy="1096560"/>
            </a:xfrm>
          </p:grpSpPr>
          <p:sp>
            <p:nvSpPr>
              <p:cNvPr id="54" name=""/>
              <p:cNvSpPr/>
              <p:nvPr/>
            </p:nvSpPr>
            <p:spPr>
              <a:xfrm>
                <a:off x="7516440" y="3535200"/>
                <a:ext cx="109440" cy="109440"/>
              </a:xfrm>
              <a:prstGeom prst="diamond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7920" bIns="79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7507080" y="3725640"/>
                <a:ext cx="109440" cy="109800"/>
              </a:xfrm>
              <a:prstGeom prst="diamond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8280" bIns="8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7503840" y="3935160"/>
                <a:ext cx="109440" cy="10008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7503840" y="4144680"/>
                <a:ext cx="109440" cy="100080"/>
              </a:xfrm>
              <a:prstGeom prst="triangle">
                <a:avLst>
                  <a:gd name="adj" fmla="val 50000"/>
                </a:avLst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7503840" y="4344840"/>
                <a:ext cx="109440" cy="10008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3320" bIns="-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7589520" y="3440160"/>
                <a:ext cx="938160" cy="1096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rf19.6899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GCY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NAT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PT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orf19.323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"/>
            <p:cNvSpPr/>
            <p:nvPr/>
          </p:nvSpPr>
          <p:spPr>
            <a:xfrm>
              <a:off x="998280" y="3140280"/>
              <a:ext cx="672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CC6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14520" y="3994200"/>
              <a:ext cx="84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CC138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826920" y="176040"/>
            <a:ext cx="3437280" cy="63900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3" name=""/>
          <p:cNvGraphicFramePr/>
          <p:nvPr/>
        </p:nvGraphicFramePr>
        <p:xfrm>
          <a:off x="4324320" y="5881680"/>
          <a:ext cx="1757520" cy="641520"/>
        </p:xfrm>
        <a:graphic>
          <a:graphicData uri="http://schemas.openxmlformats.org/drawingml/2006/table">
            <a:tbl>
              <a:tblPr/>
              <a:tblGrid>
                <a:gridCol w="300240"/>
                <a:gridCol w="1457280"/>
              </a:tblGrid>
              <a:tr h="158760"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z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score ≥ 3.0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2000"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 determin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560"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ccffff"/>
                    </a:solidFill>
                  </a:tcPr>
                </a:tc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bolic enzym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solidFill>
                      <a:srgbClr val="ffff99"/>
                    </a:solidFill>
                  </a:tcPr>
                </a:tc>
                <a:tc>
                  <a:txBody>
                    <a:bodyPr lIns="90000" rIns="90000" tIns="18360" bIns="1836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mbrane related function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1440">
                      <a:solidFill>
                        <a:srgbClr val="000000"/>
                      </a:solidFill>
                    </a:lnL>
                    <a:lnR w="1440">
                      <a:solidFill>
                        <a:srgbClr val="000000"/>
                      </a:solidFill>
                    </a:lnR>
                    <a:lnT w="1440">
                      <a:solidFill>
                        <a:srgbClr val="000000"/>
                      </a:solidFill>
                    </a:lnT>
                    <a:lnB w="144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4" name=""/>
          <p:cNvSpPr/>
          <p:nvPr/>
        </p:nvSpPr>
        <p:spPr>
          <a:xfrm>
            <a:off x="349200" y="2142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618080" y="900000"/>
            <a:ext cx="418788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amphotericin B (A), and the two ergosterol analogs, ECC69 and ECC1384 (B)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To compare the profiles of these three compounds, the top 30 most sensitive strains to each compound were selected and the three sets were combined for comparison. Highlighted in red are z-scores greater than 3.000. Strains whose corresponding genes are involved in the membrane function and metabolism are highlighte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1:07Z</dcterms:created>
  <dc:creator>xudemin</dc:creator>
  <dc:description/>
  <dc:language>en-US</dc:language>
  <cp:lastModifiedBy>xudemin</cp:lastModifiedBy>
  <dcterms:modified xsi:type="dcterms:W3CDTF">2007-05-17T15:23:11Z</dcterms:modified>
  <cp:revision>3</cp:revision>
  <dc:subject/>
  <dc:title>Slide 1</dc:title>
</cp:coreProperties>
</file>